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jpeg" ContentType="image/jpeg"/>
  <Override PartName="/ppt/media/image9.jpeg" ContentType="image/jpeg"/>
  <Override PartName="/ppt/media/image11.jpeg" ContentType="image/jpeg"/>
  <Override PartName="/ppt/media/image16.png" ContentType="image/png"/>
  <Override PartName="/ppt/media/image15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8.png" ContentType="image/png"/>
  <Override PartName="/ppt/media/image14.jpeg" ContentType="image/jpeg"/>
  <Override PartName="/ppt/media/image7.jpeg" ContentType="image/jpeg"/>
  <Override PartName="/ppt/media/image1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BDE35-827A-49DE-9855-52707C5E36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65D9AB-67E1-42BC-AA59-C8F652634A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42C7F-4676-42C3-A665-9F6BE93BBE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3C92C-4415-4361-9EFB-DF33273DDB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E3A1DC-7559-4368-AB0E-F6299FD4E3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7DE971-17CC-484A-8FC6-153B971C83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CA828-B963-48EC-9948-6C87B82432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8447B-A19F-4EEF-B387-C534FF11D6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1B9A6-AC01-4F5E-8D92-F23A4268AA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75E1B-C5EB-4E47-8892-3DEF2D274D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173C2-26DB-4727-AE2D-D88C337984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D7837-2C3C-42A1-921D-BCD840DE7B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40F68CA-9E99-40A9-AA3B-D1D88A06DAD5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A89E6E9-A6B3-4030-8CA2-C5237F19F70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MAlign_0815_23232062.jpg"/>
          <p:cNvPicPr/>
          <p:nvPr/>
        </p:nvPicPr>
        <p:blipFill>
          <a:blip r:embed="rId1"/>
          <a:stretch/>
        </p:blipFill>
        <p:spPr>
          <a:xfrm>
            <a:off x="152280" y="592200"/>
            <a:ext cx="6451560" cy="1719360"/>
          </a:xfrm>
          <a:prstGeom prst="rect">
            <a:avLst/>
          </a:prstGeom>
          <a:ln w="0">
            <a:noFill/>
          </a:ln>
        </p:spPr>
      </p:pic>
      <p:grpSp>
        <p:nvGrpSpPr>
          <p:cNvPr id="42" name="Group 11"/>
          <p:cNvGrpSpPr/>
          <p:nvPr/>
        </p:nvGrpSpPr>
        <p:grpSpPr>
          <a:xfrm>
            <a:off x="3879720" y="2644920"/>
            <a:ext cx="2511720" cy="710640"/>
            <a:chOff x="3879720" y="2644920"/>
            <a:chExt cx="2511720" cy="710640"/>
          </a:xfrm>
        </p:grpSpPr>
        <p:sp>
          <p:nvSpPr>
            <p:cNvPr id="43" name="TextBox 22"/>
            <p:cNvSpPr/>
            <p:nvPr/>
          </p:nvSpPr>
          <p:spPr>
            <a:xfrm>
              <a:off x="3879720" y="3079080"/>
              <a:ext cx="2511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NiWT    Ni1    Ni9  KiWT  Ki3 </a:t>
              </a: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	</a:t>
              </a: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Ki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45"/>
            <p:cNvGrpSpPr/>
            <p:nvPr/>
          </p:nvGrpSpPr>
          <p:grpSpPr>
            <a:xfrm>
              <a:off x="3936960" y="2644920"/>
              <a:ext cx="2238480" cy="415800"/>
              <a:chOff x="3936960" y="2644920"/>
              <a:chExt cx="2238480" cy="415800"/>
            </a:xfrm>
          </p:grpSpPr>
          <p:pic>
            <p:nvPicPr>
              <p:cNvPr id="45" name="Picture 18" descr="kita3edit"/>
              <p:cNvPicPr/>
              <p:nvPr/>
            </p:nvPicPr>
            <p:blipFill>
              <a:blip r:embed="rId2"/>
              <a:stretch/>
            </p:blipFill>
            <p:spPr>
              <a:xfrm>
                <a:off x="5378040" y="2644920"/>
                <a:ext cx="368640" cy="404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22" descr="Kita7-5edit"/>
              <p:cNvPicPr/>
              <p:nvPr/>
            </p:nvPicPr>
            <p:blipFill>
              <a:blip r:embed="rId3"/>
              <a:stretch/>
            </p:blipFill>
            <p:spPr>
              <a:xfrm>
                <a:off x="5747040" y="2644920"/>
                <a:ext cx="428400" cy="403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Picture 23" descr="F11508-wt-edit"/>
              <p:cNvPicPr/>
              <p:nvPr/>
            </p:nvPicPr>
            <p:blipFill>
              <a:blip r:embed="rId4"/>
              <a:stretch/>
            </p:blipFill>
            <p:spPr>
              <a:xfrm flipH="1">
                <a:off x="3936960" y="2653200"/>
                <a:ext cx="348480" cy="40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15" descr="kitaWTedit"/>
              <p:cNvPicPr/>
              <p:nvPr/>
            </p:nvPicPr>
            <p:blipFill>
              <a:blip r:embed="rId5"/>
              <a:stretch/>
            </p:blipFill>
            <p:spPr>
              <a:xfrm>
                <a:off x="5060160" y="2646720"/>
                <a:ext cx="319320" cy="401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9" name="Picture 27" descr="Nip1-3.JPG"/>
              <p:cNvPicPr/>
              <p:nvPr/>
            </p:nvPicPr>
            <p:blipFill>
              <a:blip r:embed="rId6"/>
              <a:stretch/>
            </p:blipFill>
            <p:spPr>
              <a:xfrm>
                <a:off x="4285440" y="2654640"/>
                <a:ext cx="419400" cy="400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Picture 25" descr="Nip9-1.JPG"/>
              <p:cNvPicPr/>
              <p:nvPr/>
            </p:nvPicPr>
            <p:blipFill>
              <a:blip r:embed="rId7"/>
              <a:stretch/>
            </p:blipFill>
            <p:spPr>
              <a:xfrm>
                <a:off x="4700880" y="2649960"/>
                <a:ext cx="360000" cy="401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1" name="Straight Connector 20"/>
              <p:cNvSpPr/>
              <p:nvPr/>
            </p:nvSpPr>
            <p:spPr>
              <a:xfrm>
                <a:off x="4242960" y="2890800"/>
                <a:ext cx="2880" cy="145800"/>
              </a:xfrm>
              <a:prstGeom prst="line">
                <a:avLst/>
              </a:prstGeom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Straight Connector 21"/>
              <p:cNvSpPr/>
              <p:nvPr/>
            </p:nvSpPr>
            <p:spPr>
              <a:xfrm>
                <a:off x="4698720" y="2881440"/>
                <a:ext cx="2880" cy="147600"/>
              </a:xfrm>
              <a:prstGeom prst="line">
                <a:avLst/>
              </a:prstGeom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3" name="Group 23"/>
          <p:cNvGrpSpPr/>
          <p:nvPr/>
        </p:nvGrpSpPr>
        <p:grpSpPr>
          <a:xfrm>
            <a:off x="206280" y="3927600"/>
            <a:ext cx="3340080" cy="2768400"/>
            <a:chOff x="206280" y="3927600"/>
            <a:chExt cx="3340080" cy="2768400"/>
          </a:xfrm>
        </p:grpSpPr>
        <p:pic>
          <p:nvPicPr>
            <p:cNvPr id="54" name="Chart 25" descr=""/>
            <p:cNvPicPr/>
            <p:nvPr/>
          </p:nvPicPr>
          <p:blipFill>
            <a:blip r:embed="rId8"/>
            <a:stretch/>
          </p:blipFill>
          <p:spPr>
            <a:xfrm>
              <a:off x="206280" y="3927600"/>
              <a:ext cx="3340080" cy="2768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TextBox 26"/>
            <p:cNvSpPr/>
            <p:nvPr/>
          </p:nvSpPr>
          <p:spPr>
            <a:xfrm>
              <a:off x="1415520" y="4169880"/>
              <a:ext cx="35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27"/>
            <p:cNvSpPr/>
            <p:nvPr/>
          </p:nvSpPr>
          <p:spPr>
            <a:xfrm>
              <a:off x="1845000" y="4024440"/>
              <a:ext cx="369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28"/>
            <p:cNvSpPr/>
            <p:nvPr/>
          </p:nvSpPr>
          <p:spPr>
            <a:xfrm>
              <a:off x="2645280" y="4011840"/>
              <a:ext cx="36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29"/>
            <p:cNvSpPr/>
            <p:nvPr/>
          </p:nvSpPr>
          <p:spPr>
            <a:xfrm>
              <a:off x="3063600" y="4077360"/>
              <a:ext cx="35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Group 29"/>
          <p:cNvGrpSpPr/>
          <p:nvPr/>
        </p:nvGrpSpPr>
        <p:grpSpPr>
          <a:xfrm>
            <a:off x="3686400" y="4417560"/>
            <a:ext cx="2665080" cy="1405440"/>
            <a:chOff x="3686400" y="4417560"/>
            <a:chExt cx="2665080" cy="1405440"/>
          </a:xfrm>
        </p:grpSpPr>
        <p:pic>
          <p:nvPicPr>
            <p:cNvPr id="60" name="Picture 30" descr="rt-pcr pistil002.jpg"/>
            <p:cNvPicPr/>
            <p:nvPr/>
          </p:nvPicPr>
          <p:blipFill>
            <a:blip r:embed="rId9"/>
            <a:stretch/>
          </p:blipFill>
          <p:spPr>
            <a:xfrm>
              <a:off x="4581000" y="4952160"/>
              <a:ext cx="1763640" cy="410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31" descr="rt-pcr pistil002.jpg"/>
            <p:cNvPicPr/>
            <p:nvPr/>
          </p:nvPicPr>
          <p:blipFill>
            <a:blip r:embed="rId10"/>
            <a:stretch/>
          </p:blipFill>
          <p:spPr>
            <a:xfrm>
              <a:off x="4570560" y="5445720"/>
              <a:ext cx="1780920" cy="377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TextBox 32"/>
            <p:cNvSpPr/>
            <p:nvPr/>
          </p:nvSpPr>
          <p:spPr>
            <a:xfrm>
              <a:off x="3832560" y="5018040"/>
              <a:ext cx="878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PGL1(3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33"/>
            <p:cNvSpPr/>
            <p:nvPr/>
          </p:nvSpPr>
          <p:spPr>
            <a:xfrm>
              <a:off x="3686400" y="5471640"/>
              <a:ext cx="941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OsActin (2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34"/>
            <p:cNvSpPr/>
            <p:nvPr/>
          </p:nvSpPr>
          <p:spPr>
            <a:xfrm rot="16200000">
              <a:off x="4474800" y="4566960"/>
              <a:ext cx="52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Ni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37"/>
            <p:cNvSpPr/>
            <p:nvPr/>
          </p:nvSpPr>
          <p:spPr>
            <a:xfrm rot="16200000">
              <a:off x="4791240" y="4611600"/>
              <a:ext cx="39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Ni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38"/>
            <p:cNvSpPr/>
            <p:nvPr/>
          </p:nvSpPr>
          <p:spPr>
            <a:xfrm rot="16200000">
              <a:off x="5081760" y="4601520"/>
              <a:ext cx="39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Ni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39"/>
            <p:cNvSpPr/>
            <p:nvPr/>
          </p:nvSpPr>
          <p:spPr>
            <a:xfrm rot="16200000">
              <a:off x="5315400" y="4532040"/>
              <a:ext cx="50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Ki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40"/>
            <p:cNvSpPr/>
            <p:nvPr/>
          </p:nvSpPr>
          <p:spPr>
            <a:xfrm rot="16200000">
              <a:off x="5671800" y="4587480"/>
              <a:ext cx="37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Ki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41"/>
            <p:cNvSpPr/>
            <p:nvPr/>
          </p:nvSpPr>
          <p:spPr>
            <a:xfrm rot="16200000">
              <a:off x="5942880" y="4585680"/>
              <a:ext cx="37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Ki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TextBox 41"/>
          <p:cNvSpPr/>
          <p:nvPr/>
        </p:nvSpPr>
        <p:spPr>
          <a:xfrm>
            <a:off x="230400" y="165240"/>
            <a:ext cx="26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42"/>
          <p:cNvSpPr/>
          <p:nvPr/>
        </p:nvSpPr>
        <p:spPr>
          <a:xfrm>
            <a:off x="208440" y="2368440"/>
            <a:ext cx="27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43"/>
          <p:cNvSpPr/>
          <p:nvPr/>
        </p:nvSpPr>
        <p:spPr>
          <a:xfrm>
            <a:off x="3621240" y="2368440"/>
            <a:ext cx="25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44"/>
          <p:cNvSpPr/>
          <p:nvPr/>
        </p:nvSpPr>
        <p:spPr>
          <a:xfrm>
            <a:off x="208440" y="3768840"/>
            <a:ext cx="27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Group 51"/>
          <p:cNvGrpSpPr/>
          <p:nvPr/>
        </p:nvGrpSpPr>
        <p:grpSpPr>
          <a:xfrm>
            <a:off x="727200" y="2389320"/>
            <a:ext cx="2836800" cy="949320"/>
            <a:chOff x="727200" y="2389320"/>
            <a:chExt cx="2836800" cy="949320"/>
          </a:xfrm>
        </p:grpSpPr>
        <p:grpSp>
          <p:nvGrpSpPr>
            <p:cNvPr id="75" name="Group 4"/>
            <p:cNvGrpSpPr/>
            <p:nvPr/>
          </p:nvGrpSpPr>
          <p:grpSpPr>
            <a:xfrm>
              <a:off x="727200" y="2611440"/>
              <a:ext cx="2836800" cy="727200"/>
              <a:chOff x="727200" y="2611440"/>
              <a:chExt cx="2836800" cy="727200"/>
            </a:xfrm>
          </p:grpSpPr>
          <p:pic>
            <p:nvPicPr>
              <p:cNvPr id="76" name="Picture 5" descr="RT-PCR05gand179007.jpg"/>
              <p:cNvPicPr/>
              <p:nvPr/>
            </p:nvPicPr>
            <p:blipFill>
              <a:blip r:embed="rId11"/>
              <a:stretch/>
            </p:blipFill>
            <p:spPr>
              <a:xfrm>
                <a:off x="728640" y="3074040"/>
                <a:ext cx="1861200" cy="264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7" name="Picture 8" descr="RT-PCR179008.jpg"/>
              <p:cNvPicPr/>
              <p:nvPr/>
            </p:nvPicPr>
            <p:blipFill>
              <a:blip r:embed="rId12"/>
              <a:stretch/>
            </p:blipFill>
            <p:spPr>
              <a:xfrm>
                <a:off x="727200" y="2611440"/>
                <a:ext cx="1863000" cy="421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8" name="TextBox 6"/>
              <p:cNvSpPr/>
              <p:nvPr/>
            </p:nvSpPr>
            <p:spPr>
              <a:xfrm>
                <a:off x="2587680" y="3074040"/>
                <a:ext cx="976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</a:rPr>
                  <a:t>OsActin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</a:rPr>
                  <a:t>(25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Box 6"/>
              <p:cNvSpPr/>
              <p:nvPr/>
            </p:nvSpPr>
            <p:spPr>
              <a:xfrm>
                <a:off x="2593440" y="2754360"/>
                <a:ext cx="803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</a:rPr>
                  <a:t>PGL1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</a:rPr>
                  <a:t>(35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0" name="TextBox 46"/>
            <p:cNvSpPr/>
            <p:nvPr/>
          </p:nvSpPr>
          <p:spPr>
            <a:xfrm>
              <a:off x="752760" y="2389320"/>
              <a:ext cx="200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G          R       L         P        L/P    Y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1" name="Straight Connector 48"/>
          <p:cNvSpPr/>
          <p:nvPr/>
        </p:nvSpPr>
        <p:spPr>
          <a:xfrm flipV="1">
            <a:off x="2895480" y="593640"/>
            <a:ext cx="914400" cy="1584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50"/>
          <p:cNvSpPr/>
          <p:nvPr/>
        </p:nvSpPr>
        <p:spPr>
          <a:xfrm>
            <a:off x="4287960" y="603360"/>
            <a:ext cx="1163520" cy="144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55"/>
          <p:cNvSpPr/>
          <p:nvPr/>
        </p:nvSpPr>
        <p:spPr>
          <a:xfrm>
            <a:off x="3797280" y="528480"/>
            <a:ext cx="476280" cy="82800"/>
          </a:xfrm>
          <a:custGeom>
            <a:avLst/>
            <a:gdLst/>
            <a:ahLst/>
            <a:rect l="l" t="t" r="r" b="b"/>
            <a:pathLst>
              <a:path w="476250" h="82550">
                <a:moveTo>
                  <a:pt x="0" y="55033"/>
                </a:moveTo>
                <a:cubicBezTo>
                  <a:pt x="69850" y="27516"/>
                  <a:pt x="139700" y="0"/>
                  <a:pt x="177800" y="4233"/>
                </a:cubicBezTo>
                <a:cubicBezTo>
                  <a:pt x="215900" y="8466"/>
                  <a:pt x="198967" y="78316"/>
                  <a:pt x="228600" y="80433"/>
                </a:cubicBezTo>
                <a:cubicBezTo>
                  <a:pt x="258233" y="82550"/>
                  <a:pt x="317500" y="19050"/>
                  <a:pt x="355600" y="16933"/>
                </a:cubicBezTo>
                <a:cubicBezTo>
                  <a:pt x="393700" y="14816"/>
                  <a:pt x="438150" y="59266"/>
                  <a:pt x="457200" y="67733"/>
                </a:cubicBezTo>
                <a:cubicBezTo>
                  <a:pt x="476250" y="76200"/>
                  <a:pt x="469900" y="67733"/>
                  <a:pt x="469900" y="67733"/>
                </a:cubicBezTo>
              </a:path>
            </a:pathLst>
          </a:custGeom>
          <a:noFill/>
          <a:ln w="25560">
            <a:solidFill>
              <a:srgbClr val="4f81bd"/>
            </a:solidFill>
            <a:round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57"/>
          <p:cNvSpPr/>
          <p:nvPr/>
        </p:nvSpPr>
        <p:spPr>
          <a:xfrm>
            <a:off x="2022480" y="604800"/>
            <a:ext cx="797040" cy="4680"/>
          </a:xfrm>
          <a:prstGeom prst="line">
            <a:avLst/>
          </a:prstGeom>
          <a:ln w="25560">
            <a:solidFill>
              <a:srgbClr val="4f81bd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47"/>
          <p:cNvSpPr/>
          <p:nvPr/>
        </p:nvSpPr>
        <p:spPr>
          <a:xfrm>
            <a:off x="3649680" y="3716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Group 3"/>
          <p:cNvGrpSpPr/>
          <p:nvPr/>
        </p:nvGrpSpPr>
        <p:grpSpPr>
          <a:xfrm>
            <a:off x="911160" y="6756480"/>
            <a:ext cx="1652760" cy="2020320"/>
            <a:chOff x="911160" y="6756480"/>
            <a:chExt cx="1652760" cy="2020320"/>
          </a:xfrm>
        </p:grpSpPr>
        <p:grpSp>
          <p:nvGrpSpPr>
            <p:cNvPr id="87" name="Group 18"/>
            <p:cNvGrpSpPr/>
            <p:nvPr/>
          </p:nvGrpSpPr>
          <p:grpSpPr>
            <a:xfrm>
              <a:off x="911160" y="6756480"/>
              <a:ext cx="1652760" cy="1713240"/>
              <a:chOff x="911160" y="6756480"/>
              <a:chExt cx="1652760" cy="1713240"/>
            </a:xfrm>
          </p:grpSpPr>
          <p:grpSp>
            <p:nvGrpSpPr>
              <p:cNvPr id="88" name="Group 8"/>
              <p:cNvGrpSpPr/>
              <p:nvPr/>
            </p:nvGrpSpPr>
            <p:grpSpPr>
              <a:xfrm>
                <a:off x="911160" y="7655760"/>
                <a:ext cx="1652760" cy="813960"/>
                <a:chOff x="911160" y="7655760"/>
                <a:chExt cx="1652760" cy="813960"/>
              </a:xfrm>
            </p:grpSpPr>
            <p:pic>
              <p:nvPicPr>
                <p:cNvPr id="89" name="Picture 4" descr="Ni10 vs WT.tiff"/>
                <p:cNvPicPr/>
                <p:nvPr/>
              </p:nvPicPr>
              <p:blipFill>
                <a:blip r:embed="rId13">
                  <a:grayscl/>
                </a:blip>
                <a:stretch/>
              </p:blipFill>
              <p:spPr>
                <a:xfrm>
                  <a:off x="911160" y="7655760"/>
                  <a:ext cx="1652760" cy="8139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0" name="Straight Connector 60"/>
                <p:cNvSpPr/>
                <p:nvPr/>
              </p:nvSpPr>
              <p:spPr>
                <a:xfrm flipV="1">
                  <a:off x="1712880" y="8123400"/>
                  <a:ext cx="0" cy="203040"/>
                </a:xfrm>
                <a:prstGeom prst="line">
                  <a:avLst/>
                </a:prstGeom>
                <a:ln w="381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91" name="Picture 9" descr="Ni10 Pistil.jpg"/>
              <p:cNvPicPr/>
              <p:nvPr/>
            </p:nvPicPr>
            <p:blipFill>
              <a:blip r:embed="rId14">
                <a:grayscl/>
              </a:blip>
              <a:stretch/>
            </p:blipFill>
            <p:spPr>
              <a:xfrm>
                <a:off x="1761120" y="6756480"/>
                <a:ext cx="802800" cy="909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2" name="Picture 10" descr="NBWT pistil.jpg"/>
              <p:cNvPicPr/>
              <p:nvPr/>
            </p:nvPicPr>
            <p:blipFill>
              <a:blip r:embed="rId15">
                <a:grayscl/>
              </a:blip>
              <a:stretch/>
            </p:blipFill>
            <p:spPr>
              <a:xfrm>
                <a:off x="911160" y="6756480"/>
                <a:ext cx="884880" cy="927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3" name="Straight Connector 58"/>
              <p:cNvSpPr/>
              <p:nvPr/>
            </p:nvSpPr>
            <p:spPr>
              <a:xfrm flipV="1">
                <a:off x="1774800" y="7108560"/>
                <a:ext cx="1440" cy="539640"/>
              </a:xfrm>
              <a:prstGeom prst="line">
                <a:avLst/>
              </a:prstGeom>
              <a:ln w="381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4" name="TextBox 19"/>
            <p:cNvSpPr/>
            <p:nvPr/>
          </p:nvSpPr>
          <p:spPr>
            <a:xfrm>
              <a:off x="1067040" y="8469720"/>
              <a:ext cx="1496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WT              Ni1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5" name="Chart 61" descr=""/>
          <p:cNvPicPr/>
          <p:nvPr/>
        </p:nvPicPr>
        <p:blipFill>
          <a:blip r:embed="rId16"/>
          <a:stretch/>
        </p:blipFill>
        <p:spPr>
          <a:xfrm>
            <a:off x="3371760" y="6377040"/>
            <a:ext cx="3237120" cy="2614680"/>
          </a:xfrm>
          <a:prstGeom prst="rect">
            <a:avLst/>
          </a:prstGeom>
          <a:ln w="0">
            <a:noFill/>
          </a:ln>
        </p:spPr>
      </p:pic>
      <p:sp>
        <p:nvSpPr>
          <p:cNvPr id="96" name="TextBox 62"/>
          <p:cNvSpPr/>
          <p:nvPr/>
        </p:nvSpPr>
        <p:spPr>
          <a:xfrm>
            <a:off x="227160" y="6475320"/>
            <a:ext cx="22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63"/>
          <p:cNvSpPr/>
          <p:nvPr/>
        </p:nvSpPr>
        <p:spPr>
          <a:xfrm>
            <a:off x="3694680" y="6378480"/>
            <a:ext cx="25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30T11:31:14Z</dcterms:created>
  <dc:creator>Dany Heang</dc:creator>
  <dc:description/>
  <dc:language>en-US</dc:language>
  <cp:lastModifiedBy>佐々 英徳</cp:lastModifiedBy>
  <cp:lastPrinted>2012-01-11T00:09:39Z</cp:lastPrinted>
  <dcterms:modified xsi:type="dcterms:W3CDTF">2012-01-11T00:10:41Z</dcterms:modified>
  <cp:revision>2</cp:revision>
  <dc:subject/>
  <dc:title>Slide 1</dc:title>
</cp:coreProperties>
</file>